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057BC0-B627-4858-86AB-1DA335EA4AC5}" v="4" dt="2025-07-09T19:45:16.679"/>
    <p1510:client id="{80991548-4828-4B0C-8472-EAC2B0178C3A}" v="4" dt="2025-07-09T19:35:46.2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45057BC0-B627-4858-86AB-1DA335EA4AC5}"/>
    <pc:docChg chg="custSel modSld">
      <pc:chgData name="Davids, Daniel" userId="bd69870e-14b0-4b2a-a293-a297d41864dd" providerId="ADAL" clId="{45057BC0-B627-4858-86AB-1DA335EA4AC5}" dt="2025-07-09T19:45:20.248" v="6" actId="1076"/>
      <pc:docMkLst>
        <pc:docMk/>
      </pc:docMkLst>
      <pc:sldChg chg="addSp delSp modSp mod">
        <pc:chgData name="Davids, Daniel" userId="bd69870e-14b0-4b2a-a293-a297d41864dd" providerId="ADAL" clId="{45057BC0-B627-4858-86AB-1DA335EA4AC5}" dt="2025-07-09T19:45:20.248" v="6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45057BC0-B627-4858-86AB-1DA335EA4AC5}" dt="2025-07-09T19:41:13.990" v="1"/>
          <ac:graphicFrameMkLst>
            <pc:docMk/>
            <pc:sldMk cId="174092475" sldId="257"/>
            <ac:graphicFrameMk id="2" creationId="{40DDF006-5C88-C771-E745-44A5D05F26A0}"/>
          </ac:graphicFrameMkLst>
        </pc:graphicFrameChg>
        <pc:graphicFrameChg chg="add del mod">
          <ac:chgData name="Davids, Daniel" userId="bd69870e-14b0-4b2a-a293-a297d41864dd" providerId="ADAL" clId="{45057BC0-B627-4858-86AB-1DA335EA4AC5}" dt="2025-07-09T19:45:08.775" v="4" actId="478"/>
          <ac:graphicFrameMkLst>
            <pc:docMk/>
            <pc:sldMk cId="174092475" sldId="257"/>
            <ac:graphicFrameMk id="3" creationId="{7E6C726A-41BB-30F4-2494-1C698589B841}"/>
          </ac:graphicFrameMkLst>
        </pc:graphicFrameChg>
        <pc:graphicFrameChg chg="del">
          <ac:chgData name="Davids, Daniel" userId="bd69870e-14b0-4b2a-a293-a297d41864dd" providerId="ADAL" clId="{45057BC0-B627-4858-86AB-1DA335EA4AC5}" dt="2025-07-09T19:41:12.368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  <pc:graphicFrameChg chg="add mod">
          <ac:chgData name="Davids, Daniel" userId="bd69870e-14b0-4b2a-a293-a297d41864dd" providerId="ADAL" clId="{45057BC0-B627-4858-86AB-1DA335EA4AC5}" dt="2025-07-09T19:45:20.248" v="6" actId="1076"/>
          <ac:graphicFrameMkLst>
            <pc:docMk/>
            <pc:sldMk cId="174092475" sldId="257"/>
            <ac:graphicFrameMk id="5" creationId="{19A9014A-B3BE-6A17-FB51-20EB7191FB0D}"/>
          </ac:graphicFrameMkLst>
        </pc:graphicFrameChg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9A9014A-B3BE-6A17-FB51-20EB7191FB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4556483"/>
              </p:ext>
            </p:extLst>
          </p:nvPr>
        </p:nvGraphicFramePr>
        <p:xfrm>
          <a:off x="1631950" y="2250599"/>
          <a:ext cx="8928100" cy="1463040"/>
        </p:xfrm>
        <a:graphic>
          <a:graphicData uri="http://schemas.openxmlformats.org/drawingml/2006/table">
            <a:tbl>
              <a:tblPr firstRow="1" firstCol="1" bandRow="1"/>
              <a:tblGrid>
                <a:gridCol w="1620520">
                  <a:extLst>
                    <a:ext uri="{9D8B030D-6E8A-4147-A177-3AD203B41FA5}">
                      <a16:colId xmlns:a16="http://schemas.microsoft.com/office/drawing/2014/main" val="2456312562"/>
                    </a:ext>
                  </a:extLst>
                </a:gridCol>
                <a:gridCol w="1694180">
                  <a:extLst>
                    <a:ext uri="{9D8B030D-6E8A-4147-A177-3AD203B41FA5}">
                      <a16:colId xmlns:a16="http://schemas.microsoft.com/office/drawing/2014/main" val="2575164383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1913151848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1503575459"/>
                    </a:ext>
                  </a:extLst>
                </a:gridCol>
                <a:gridCol w="1460500">
                  <a:extLst>
                    <a:ext uri="{9D8B030D-6E8A-4147-A177-3AD203B41FA5}">
                      <a16:colId xmlns:a16="http://schemas.microsoft.com/office/drawing/2014/main" val="1369605892"/>
                    </a:ext>
                  </a:extLst>
                </a:gridCol>
                <a:gridCol w="1384300">
                  <a:extLst>
                    <a:ext uri="{9D8B030D-6E8A-4147-A177-3AD203B41FA5}">
                      <a16:colId xmlns:a16="http://schemas.microsoft.com/office/drawing/2014/main" val="3310303257"/>
                    </a:ext>
                  </a:extLst>
                </a:gridCol>
              </a:tblGrid>
              <a:tr h="18288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969522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2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5% Methane Leak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72490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4.28512 ± 0.4752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.34032 ± 7.2783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5.01044 ± 5.6196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6.93055 ± 24.5186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19808 ± 6.881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329757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.12537 ± 8.876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.91148 ± 70.431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0.86171 ± 33.5737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.74411 ± 106.3207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.31963 ± 19.314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1177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.14193 ± 36.2319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96.05692 ± 163.189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232.12873 ± 49.288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97.64074 ± 114.2042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9.24667 ± 13.499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551685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11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313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2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132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15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078562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84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664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58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196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752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47255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95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99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874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588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257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44778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114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5:21Z</dcterms:modified>
</cp:coreProperties>
</file>